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240" y="-8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7.03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-2233"/>
            <a:ext cx="889248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2. </a:t>
            </a:r>
            <a:r>
              <a:rPr lang="en-US" altLang="ru-RU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Hierarchical cluster analysis of all DEGs in the STR-V vs. NS-V; STR-S vs. </a:t>
            </a:r>
            <a:r>
              <a:rPr lang="en-US" altLang="ru-RU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S-S </a:t>
            </a:r>
            <a:r>
              <a:rPr lang="en-US" altLang="ru-RU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 STR-A vs. </a:t>
            </a:r>
            <a:r>
              <a:rPr lang="en-US" altLang="ru-RU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S-A pairwise </a:t>
            </a:r>
            <a:r>
              <a:rPr lang="en-US" altLang="ru-RU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mparisons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5608" y="6023029"/>
            <a:ext cx="9128392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endParaRPr kumimoji="0" lang="ru-RU" altLang="ru-RU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ach 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lumn represents a comparison group, and each row represents a DEG. Yellow strips represent high relative expression and blue strips represent low relative expression (n = 3 per group).</a:t>
            </a:r>
            <a:endParaRPr kumimoji="0" lang="en-US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J:\Редактируемые\Для публикаций\0_текущие публикации\стресс_2\статья по стрессу2\в Журналы\2_Hormone and behav\рецензия\FigS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0" y="649606"/>
            <a:ext cx="9103984" cy="51641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670488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2</Words>
  <Application>Microsoft Office PowerPoint</Application>
  <PresentationFormat>Экран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2</cp:revision>
  <dcterms:created xsi:type="dcterms:W3CDTF">2020-12-07T15:39:17Z</dcterms:created>
  <dcterms:modified xsi:type="dcterms:W3CDTF">2021-03-17T10:07:30Z</dcterms:modified>
</cp:coreProperties>
</file>